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352"/>
    <p:restoredTop sz="94666"/>
  </p:normalViewPr>
  <p:slideViewPr>
    <p:cSldViewPr snapToGrid="0" snapToObjects="1">
      <p:cViewPr varScale="1">
        <p:scale>
          <a:sx n="104" d="100"/>
          <a:sy n="104" d="100"/>
        </p:scale>
        <p:origin x="28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7A764B-3B5C-1D49-BEE1-E57D5ACADF6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37A7197-573A-9C4D-B5A0-B46733E6602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2A1A7F-E0E0-2F4D-8245-57A2D201B8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6175C-6C97-924C-8CDE-C92FC1198368}" type="datetimeFigureOut">
              <a:rPr lang="en-US" smtClean="0"/>
              <a:t>6/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A2A205-706D-CF4C-9A60-DE48785923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562A34-AD90-6F45-AE9D-5470308940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01BF0-4158-AD44-8A2C-43F6A7C2A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87091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72EDA-3F89-D941-B94A-35B7FC0BC1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3F9D503-0950-9142-9AAD-94BC8135F3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C0F7D8-C5FC-4642-9661-87F0ECFF46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6175C-6C97-924C-8CDE-C92FC1198368}" type="datetimeFigureOut">
              <a:rPr lang="en-US" smtClean="0"/>
              <a:t>6/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D212A3-EB8C-AB46-AC31-D2FCDFD258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D42DC3-48F8-994D-A7B8-647806BED0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01BF0-4158-AD44-8A2C-43F6A7C2A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46066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44F2F7C-92F9-2C48-94FA-E9400EE4C33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B0B49D-C808-164D-A65B-553804E338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BCED15-CF10-934A-A812-78BD9D4341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6175C-6C97-924C-8CDE-C92FC1198368}" type="datetimeFigureOut">
              <a:rPr lang="en-US" smtClean="0"/>
              <a:t>6/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84A4C3-DF7F-8A48-9B3F-BA2A73589D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6C965B-CD00-544F-8D0D-6851D8EF66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01BF0-4158-AD44-8A2C-43F6A7C2A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65106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33F31E-098E-DA49-B330-CB0459D3B1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72AC7C-8C6F-5840-AEFC-A30D2597B3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63ADAE-DB64-E24A-8F9C-147C33FCF8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6175C-6C97-924C-8CDE-C92FC1198368}" type="datetimeFigureOut">
              <a:rPr lang="en-US" smtClean="0"/>
              <a:t>6/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E235F4-204D-6546-B55A-5413729E66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D430B4-A864-D84F-AEAF-94EA477148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01BF0-4158-AD44-8A2C-43F6A7C2A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29582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B0CE8A-60C4-3643-9D6B-8CE17C6BEE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F340DE-A553-624A-AD48-87FA75D74B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815145-037E-6049-BF13-AC80D4AC22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6175C-6C97-924C-8CDE-C92FC1198368}" type="datetimeFigureOut">
              <a:rPr lang="en-US" smtClean="0"/>
              <a:t>6/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14656C-86DA-CA45-987F-D08DA85B64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CCDE1C-DE73-9C48-8C2F-5281F2A8BC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01BF0-4158-AD44-8A2C-43F6A7C2A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65680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23EC53-60E1-B940-876E-AEF46F0504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AA1A95-7DCF-6745-976A-69414727BF1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21F3D95-9C0C-8C43-B6F2-A6DC7AC138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1FF9C02-377E-C842-A58E-1412CB941A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6175C-6C97-924C-8CDE-C92FC1198368}" type="datetimeFigureOut">
              <a:rPr lang="en-US" smtClean="0"/>
              <a:t>6/5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55BA2ED-50FD-0B40-B325-2F5DBA1108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8410F4B-CCBE-F24D-9239-E0232323F6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01BF0-4158-AD44-8A2C-43F6A7C2A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00631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3EEAF8-1C78-3E4A-9376-78A8642370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93348BE-05A9-674E-B364-5A2A3D6C74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CF83DFF-1D3F-9446-9758-3E704A308B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D8483B4-D736-0844-A49A-D7BE847EEE2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A2FBB4C-2875-CB41-921B-9569B190AE4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7C5828F-BE60-9644-AF07-3C5E7835EC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6175C-6C97-924C-8CDE-C92FC1198368}" type="datetimeFigureOut">
              <a:rPr lang="en-US" smtClean="0"/>
              <a:t>6/5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5EF3945-0557-5847-9BEC-ACA0245A14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93F0095-6FFA-4145-B2DC-FEF66769A3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01BF0-4158-AD44-8A2C-43F6A7C2A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0564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D9F689-1F1F-9F48-8C21-4650F23369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AE26AFA-D261-BB4C-84E9-6731267D29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6175C-6C97-924C-8CDE-C92FC1198368}" type="datetimeFigureOut">
              <a:rPr lang="en-US" smtClean="0"/>
              <a:t>6/5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BFB6F0C-5998-3148-8B29-C9E999A7FD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AFD3FCF-5280-A541-9F3F-6C03395E73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01BF0-4158-AD44-8A2C-43F6A7C2A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47015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B6E325D-002D-4644-9597-E013152140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6175C-6C97-924C-8CDE-C92FC1198368}" type="datetimeFigureOut">
              <a:rPr lang="en-US" smtClean="0"/>
              <a:t>6/5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9CF2A40-4E38-DE4E-ADB5-469E402FDF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98A29F5-FAB1-564D-BBD2-DCBD674AF2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01BF0-4158-AD44-8A2C-43F6A7C2A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38768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46E92B-A31A-4345-811F-CE272ACEF2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6E32D8-5AFF-A945-B842-9E7EC8F0172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089D17E-A277-A94D-B28D-E067E920AF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6AFDF09-BF70-B245-8917-6DF6282149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6175C-6C97-924C-8CDE-C92FC1198368}" type="datetimeFigureOut">
              <a:rPr lang="en-US" smtClean="0"/>
              <a:t>6/5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5ADED0C-2480-7B41-BF88-E03F214AB5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6BFDCEB-7972-D443-BA1F-1F5AF55B6D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01BF0-4158-AD44-8A2C-43F6A7C2A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4492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76CE00-EDB8-1F41-9073-75C3C782A6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E526A50-A6CB-0841-B81B-0E67C8F5D51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07A963A-20BD-2240-B97A-DDB418A42F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97D353-63E8-B949-A847-E27345C279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6175C-6C97-924C-8CDE-C92FC1198368}" type="datetimeFigureOut">
              <a:rPr lang="en-US" smtClean="0"/>
              <a:t>6/5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F99A260-14B6-1E42-9CE1-8F21452320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1EF4A1-4C8A-CA46-AB58-81542D6327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01BF0-4158-AD44-8A2C-43F6A7C2A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96392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4B939CD-E74B-3740-9834-B73A50EC21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08A144-0438-1F46-A172-1AF1924FE0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5F49A7-B792-B844-A583-3F50459784D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76175C-6C97-924C-8CDE-C92FC1198368}" type="datetimeFigureOut">
              <a:rPr lang="en-US" smtClean="0"/>
              <a:t>6/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A8AA87-9E7F-4249-84C2-314CC08732D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45F9F7-6714-7B44-952C-60294389876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701BF0-4158-AD44-8A2C-43F6A7C2A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61063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emf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>
            <a:extLst>
              <a:ext uri="{FF2B5EF4-FFF2-40B4-BE49-F238E27FC236}">
                <a16:creationId xmlns:a16="http://schemas.microsoft.com/office/drawing/2014/main" id="{F0A1F164-6579-6047-85E4-3EA3B1579BCB}"/>
              </a:ext>
            </a:extLst>
          </p:cNvPr>
          <p:cNvSpPr txBox="1"/>
          <p:nvPr/>
        </p:nvSpPr>
        <p:spPr>
          <a:xfrm>
            <a:off x="401256" y="634359"/>
            <a:ext cx="8442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24A8D061-BD99-E34D-AEE2-00C9480C8A0E}"/>
              </a:ext>
            </a:extLst>
          </p:cNvPr>
          <p:cNvGrpSpPr/>
          <p:nvPr/>
        </p:nvGrpSpPr>
        <p:grpSpPr>
          <a:xfrm>
            <a:off x="484440" y="759196"/>
            <a:ext cx="3752654" cy="2131290"/>
            <a:chOff x="276697" y="525338"/>
            <a:chExt cx="4314920" cy="2450625"/>
          </a:xfrm>
        </p:grpSpPr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FCCD9670-0473-4346-93D3-B9DFDC83538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41680" y="868012"/>
              <a:ext cx="2107950" cy="2107951"/>
            </a:xfrm>
            <a:prstGeom prst="rect">
              <a:avLst/>
            </a:prstGeom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9C3406DA-A3D0-2C47-B583-4071F8C6ED5D}"/>
                </a:ext>
              </a:extLst>
            </p:cNvPr>
            <p:cNvSpPr txBox="1"/>
            <p:nvPr/>
          </p:nvSpPr>
          <p:spPr>
            <a:xfrm rot="16200000">
              <a:off x="-26213" y="1788732"/>
              <a:ext cx="995099" cy="3892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M20</a:t>
              </a:r>
            </a:p>
          </p:txBody>
        </p: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787999BD-8088-CA48-BD4C-23B8DB5AEE3C}"/>
                </a:ext>
              </a:extLst>
            </p:cNvPr>
            <p:cNvCxnSpPr>
              <a:cxnSpLocks/>
            </p:cNvCxnSpPr>
            <p:nvPr/>
          </p:nvCxnSpPr>
          <p:spPr>
            <a:xfrm>
              <a:off x="2139788" y="2879968"/>
              <a:ext cx="536017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6A5B813F-BE70-6A47-8BD8-0E9AE94BEB11}"/>
                </a:ext>
              </a:extLst>
            </p:cNvPr>
            <p:cNvSpPr txBox="1"/>
            <p:nvPr/>
          </p:nvSpPr>
          <p:spPr>
            <a:xfrm>
              <a:off x="1294685" y="525338"/>
              <a:ext cx="84510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C401C533-664D-6A49-BBF3-87C79529065A}"/>
                </a:ext>
              </a:extLst>
            </p:cNvPr>
            <p:cNvSpPr txBox="1"/>
            <p:nvPr/>
          </p:nvSpPr>
          <p:spPr>
            <a:xfrm>
              <a:off x="3212841" y="525338"/>
              <a:ext cx="137877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SARS-CoV-2</a:t>
              </a:r>
            </a:p>
          </p:txBody>
        </p:sp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B87A8ECA-5FB2-EB4F-87D3-45E68E7F080A}"/>
              </a:ext>
            </a:extLst>
          </p:cNvPr>
          <p:cNvSpPr txBox="1"/>
          <p:nvPr/>
        </p:nvSpPr>
        <p:spPr>
          <a:xfrm>
            <a:off x="251494" y="3416881"/>
            <a:ext cx="8442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F73B360-3785-DF48-B65B-3EFCA5EAD8AE}"/>
              </a:ext>
            </a:extLst>
          </p:cNvPr>
          <p:cNvSpPr txBox="1"/>
          <p:nvPr/>
        </p:nvSpPr>
        <p:spPr>
          <a:xfrm>
            <a:off x="33274" y="-19220"/>
            <a:ext cx="11592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sz="240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A094644-B7D2-A84A-AD09-3E2D4FB89BC9}"/>
              </a:ext>
            </a:extLst>
          </p:cNvPr>
          <p:cNvSpPr txBox="1"/>
          <p:nvPr/>
        </p:nvSpPr>
        <p:spPr>
          <a:xfrm>
            <a:off x="5320438" y="657106"/>
            <a:ext cx="8442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CEA4B06A-6F43-874F-B23A-23B763F9C451}"/>
              </a:ext>
            </a:extLst>
          </p:cNvPr>
          <p:cNvGrpSpPr/>
          <p:nvPr/>
        </p:nvGrpSpPr>
        <p:grpSpPr>
          <a:xfrm>
            <a:off x="422421" y="3506908"/>
            <a:ext cx="4596966" cy="3110747"/>
            <a:chOff x="6081962" y="414396"/>
            <a:chExt cx="4596966" cy="3110747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45EA6D85-1D7E-B44F-BD94-4E0213115A1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 flipH="1">
              <a:off x="9307328" y="2153543"/>
              <a:ext cx="1371600" cy="137160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FCC5F535-249D-4E48-9862-237AE400E0D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 flipH="1">
              <a:off x="7890299" y="2153542"/>
              <a:ext cx="1371600" cy="137160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BE4BB78E-CD11-EC47-8568-EE4145C80BD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 flipH="1">
              <a:off x="6465944" y="2153542"/>
              <a:ext cx="1371600" cy="13716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3193EB5C-E2B1-6844-AFA7-13BBC93DA85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9307328" y="729187"/>
              <a:ext cx="1371600" cy="137160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2043DC1F-85C3-5540-B500-C23E81A6B91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890299" y="729187"/>
              <a:ext cx="1371600" cy="1371600"/>
            </a:xfrm>
            <a:prstGeom prst="rect">
              <a:avLst/>
            </a:prstGeom>
          </p:spPr>
        </p:pic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1983823-6326-9C4B-BEB6-110995BF00CD}"/>
                </a:ext>
              </a:extLst>
            </p:cNvPr>
            <p:cNvSpPr txBox="1"/>
            <p:nvPr/>
          </p:nvSpPr>
          <p:spPr>
            <a:xfrm rot="16200000">
              <a:off x="5828687" y="1270522"/>
              <a:ext cx="84510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1657EFCD-6AE9-1C4D-AD8D-4BA0AB68F702}"/>
                </a:ext>
              </a:extLst>
            </p:cNvPr>
            <p:cNvSpPr txBox="1"/>
            <p:nvPr/>
          </p:nvSpPr>
          <p:spPr>
            <a:xfrm rot="16200000">
              <a:off x="5561851" y="2522591"/>
              <a:ext cx="137877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SARS-CoV-2</a:t>
              </a:r>
            </a:p>
          </p:txBody>
        </p: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193263FE-46C1-314F-97DF-E0D5AFAF4749}"/>
                </a:ext>
              </a:extLst>
            </p:cNvPr>
            <p:cNvGrpSpPr/>
            <p:nvPr/>
          </p:nvGrpSpPr>
          <p:grpSpPr>
            <a:xfrm>
              <a:off x="6465944" y="729187"/>
              <a:ext cx="1371600" cy="1371600"/>
              <a:chOff x="6465944" y="729187"/>
              <a:chExt cx="1371600" cy="1371600"/>
            </a:xfrm>
          </p:grpSpPr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FA1C1FA7-86C3-A24E-89E0-B54C8558982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6465944" y="729187"/>
                <a:ext cx="1371600" cy="1371600"/>
              </a:xfrm>
              <a:prstGeom prst="rect">
                <a:avLst/>
              </a:prstGeom>
            </p:spPr>
          </p:pic>
          <p:cxnSp>
            <p:nvCxnSpPr>
              <p:cNvPr id="35" name="Straight Connector 34">
                <a:extLst>
                  <a:ext uri="{FF2B5EF4-FFF2-40B4-BE49-F238E27FC236}">
                    <a16:creationId xmlns:a16="http://schemas.microsoft.com/office/drawing/2014/main" id="{B3BD29A5-EE52-A343-AC3C-B39285B2B3F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340957" y="2028379"/>
                <a:ext cx="445071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804F9C04-156B-A340-B7B5-0BBDD1A3D68F}"/>
                </a:ext>
              </a:extLst>
            </p:cNvPr>
            <p:cNvSpPr txBox="1"/>
            <p:nvPr/>
          </p:nvSpPr>
          <p:spPr>
            <a:xfrm>
              <a:off x="6781694" y="414396"/>
              <a:ext cx="365991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solidFill>
                    <a:srgbClr val="FF4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</a:t>
              </a:r>
              <a:r>
                <a:rPr lang="en-US" sz="16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ge</a:t>
              </a:r>
              <a:r>
                <a:rPr lang="en-US" sz="1600" dirty="0">
                  <a:solidFill>
                    <a:srgbClr val="FF4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    TFAM</a:t>
              </a:r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</a:t>
              </a:r>
              <a:r>
                <a:rPr lang="en-US" sz="16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M20</a:t>
              </a:r>
            </a:p>
          </p:txBody>
        </p:sp>
      </p:grpSp>
      <p:sp>
        <p:nvSpPr>
          <p:cNvPr id="37" name="TextBox 36">
            <a:extLst>
              <a:ext uri="{FF2B5EF4-FFF2-40B4-BE49-F238E27FC236}">
                <a16:creationId xmlns:a16="http://schemas.microsoft.com/office/drawing/2014/main" id="{519CA308-D1AA-654A-9E2B-06D22CBBA563}"/>
              </a:ext>
            </a:extLst>
          </p:cNvPr>
          <p:cNvSpPr txBox="1"/>
          <p:nvPr/>
        </p:nvSpPr>
        <p:spPr>
          <a:xfrm>
            <a:off x="8703286" y="630994"/>
            <a:ext cx="8442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4400C8D-4E06-694B-828C-EC524046BA19}"/>
              </a:ext>
            </a:extLst>
          </p:cNvPr>
          <p:cNvSpPr txBox="1"/>
          <p:nvPr/>
        </p:nvSpPr>
        <p:spPr>
          <a:xfrm>
            <a:off x="6080816" y="2960585"/>
            <a:ext cx="8442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D80C30B0-A060-144D-A7C0-61AABBFD8C6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502957" y="2995790"/>
            <a:ext cx="3911600" cy="3606800"/>
          </a:xfrm>
          <a:prstGeom prst="rect">
            <a:avLst/>
          </a:prstGeom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id="{EBF440B1-89E3-A541-AAF4-D95A884974BE}"/>
              </a:ext>
            </a:extLst>
          </p:cNvPr>
          <p:cNvSpPr txBox="1"/>
          <p:nvPr/>
        </p:nvSpPr>
        <p:spPr>
          <a:xfrm>
            <a:off x="6007320" y="862906"/>
            <a:ext cx="734980" cy="2944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3E679843-DFD0-454D-8517-C1D986109E09}"/>
              </a:ext>
            </a:extLst>
          </p:cNvPr>
          <p:cNvSpPr txBox="1"/>
          <p:nvPr/>
        </p:nvSpPr>
        <p:spPr>
          <a:xfrm>
            <a:off x="7161870" y="862906"/>
            <a:ext cx="1199111" cy="2944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ARS-CoV-2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FE26EA06-6898-0C41-A9C3-1B3A2547D6BF}"/>
              </a:ext>
            </a:extLst>
          </p:cNvPr>
          <p:cNvSpPr txBox="1"/>
          <p:nvPr/>
        </p:nvSpPr>
        <p:spPr>
          <a:xfrm>
            <a:off x="9278437" y="833426"/>
            <a:ext cx="734980" cy="2944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BEA6F1B-825D-FC4D-9A2F-5886F7441D9F}"/>
              </a:ext>
            </a:extLst>
          </p:cNvPr>
          <p:cNvSpPr txBox="1"/>
          <p:nvPr/>
        </p:nvSpPr>
        <p:spPr>
          <a:xfrm>
            <a:off x="10507937" y="833426"/>
            <a:ext cx="1199111" cy="2944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ARS-CoV-2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57675717-78D4-304B-AD9C-2D4165715CB6}"/>
              </a:ext>
            </a:extLst>
          </p:cNvPr>
          <p:cNvSpPr txBox="1"/>
          <p:nvPr/>
        </p:nvSpPr>
        <p:spPr>
          <a:xfrm rot="16200000">
            <a:off x="4810160" y="1662356"/>
            <a:ext cx="13901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r>
              <a:rPr lang="en-US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GAS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E453B52-AFC8-7F45-9A97-9F4897957B32}"/>
              </a:ext>
            </a:extLst>
          </p:cNvPr>
          <p:cNvSpPr txBox="1"/>
          <p:nvPr/>
        </p:nvSpPr>
        <p:spPr>
          <a:xfrm rot="16200000">
            <a:off x="8060478" y="1654012"/>
            <a:ext cx="1531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r>
              <a:rPr lang="en-US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LRP3</a:t>
            </a:r>
          </a:p>
        </p:txBody>
      </p:sp>
      <p:grpSp>
        <p:nvGrpSpPr>
          <p:cNvPr id="61" name="Group 60">
            <a:extLst>
              <a:ext uri="{FF2B5EF4-FFF2-40B4-BE49-F238E27FC236}">
                <a16:creationId xmlns:a16="http://schemas.microsoft.com/office/drawing/2014/main" id="{367F6A72-0C05-FC40-AB92-AF2667987C7A}"/>
              </a:ext>
            </a:extLst>
          </p:cNvPr>
          <p:cNvGrpSpPr/>
          <p:nvPr/>
        </p:nvGrpSpPr>
        <p:grpSpPr>
          <a:xfrm>
            <a:off x="5658674" y="1143616"/>
            <a:ext cx="2891453" cy="1416657"/>
            <a:chOff x="5658674" y="1143616"/>
            <a:chExt cx="2891453" cy="1416657"/>
          </a:xfrm>
        </p:grpSpPr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C730274F-F9F0-A240-92CE-3F973E89A829}"/>
                </a:ext>
              </a:extLst>
            </p:cNvPr>
            <p:cNvGrpSpPr/>
            <p:nvPr/>
          </p:nvGrpSpPr>
          <p:grpSpPr>
            <a:xfrm>
              <a:off x="5658674" y="1143616"/>
              <a:ext cx="2891453" cy="1416657"/>
              <a:chOff x="6645056" y="1111855"/>
              <a:chExt cx="2519659" cy="1234498"/>
            </a:xfrm>
          </p:grpSpPr>
          <p:pic>
            <p:nvPicPr>
              <p:cNvPr id="16" name="Picture 15">
                <a:extLst>
                  <a:ext uri="{FF2B5EF4-FFF2-40B4-BE49-F238E27FC236}">
                    <a16:creationId xmlns:a16="http://schemas.microsoft.com/office/drawing/2014/main" id="{22FAD82B-0474-EC45-8349-60BD0C56520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7930217" y="1111855"/>
                <a:ext cx="1234498" cy="1234498"/>
              </a:xfrm>
              <a:prstGeom prst="rect">
                <a:avLst/>
              </a:prstGeom>
            </p:spPr>
          </p:pic>
          <p:pic>
            <p:nvPicPr>
              <p:cNvPr id="18" name="Picture 17">
                <a:extLst>
                  <a:ext uri="{FF2B5EF4-FFF2-40B4-BE49-F238E27FC236}">
                    <a16:creationId xmlns:a16="http://schemas.microsoft.com/office/drawing/2014/main" id="{AAC9137A-D7DB-B947-B78F-F3CE14EDBEA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6645056" y="1111855"/>
                <a:ext cx="1234498" cy="1234498"/>
              </a:xfrm>
              <a:prstGeom prst="rect">
                <a:avLst/>
              </a:prstGeom>
            </p:spPr>
          </p:pic>
        </p:grp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B64C8938-E8A3-A540-8249-95D7D1CB6248}"/>
                </a:ext>
              </a:extLst>
            </p:cNvPr>
            <p:cNvCxnSpPr>
              <a:cxnSpLocks/>
            </p:cNvCxnSpPr>
            <p:nvPr/>
          </p:nvCxnSpPr>
          <p:spPr>
            <a:xfrm>
              <a:off x="6353503" y="2484798"/>
              <a:ext cx="691846" cy="6394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47" name="Picture 46">
            <a:extLst>
              <a:ext uri="{FF2B5EF4-FFF2-40B4-BE49-F238E27FC236}">
                <a16:creationId xmlns:a16="http://schemas.microsoft.com/office/drawing/2014/main" id="{784CD56D-EF2B-FC4A-859F-575572C7AD6E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0483668" y="1127865"/>
            <a:ext cx="1401908" cy="1401908"/>
          </a:xfrm>
          <a:prstGeom prst="rect">
            <a:avLst/>
          </a:prstGeom>
        </p:spPr>
      </p:pic>
      <p:grpSp>
        <p:nvGrpSpPr>
          <p:cNvPr id="48" name="Group 47">
            <a:extLst>
              <a:ext uri="{FF2B5EF4-FFF2-40B4-BE49-F238E27FC236}">
                <a16:creationId xmlns:a16="http://schemas.microsoft.com/office/drawing/2014/main" id="{A69CABA1-BF4A-5C42-97FE-1E2C27EA94F0}"/>
              </a:ext>
            </a:extLst>
          </p:cNvPr>
          <p:cNvGrpSpPr/>
          <p:nvPr/>
        </p:nvGrpSpPr>
        <p:grpSpPr>
          <a:xfrm>
            <a:off x="9010738" y="1127864"/>
            <a:ext cx="1401908" cy="1401908"/>
            <a:chOff x="9010738" y="1127864"/>
            <a:chExt cx="1401908" cy="1401908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40BD7991-1DB5-B34F-A01C-72B74A8CAF4F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9010738" y="1127864"/>
              <a:ext cx="1401908" cy="1401908"/>
            </a:xfrm>
            <a:prstGeom prst="rect">
              <a:avLst/>
            </a:prstGeom>
          </p:spPr>
        </p:pic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C87FC88E-27D1-9743-A4E3-3316C1144CDA}"/>
                </a:ext>
              </a:extLst>
            </p:cNvPr>
            <p:cNvCxnSpPr>
              <a:cxnSpLocks/>
            </p:cNvCxnSpPr>
            <p:nvPr/>
          </p:nvCxnSpPr>
          <p:spPr>
            <a:xfrm>
              <a:off x="9695793" y="2484798"/>
              <a:ext cx="631853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1" name="Picture 10">
            <a:extLst>
              <a:ext uri="{FF2B5EF4-FFF2-40B4-BE49-F238E27FC236}">
                <a16:creationId xmlns:a16="http://schemas.microsoft.com/office/drawing/2014/main" id="{D5370550-06BF-CC4E-9BB5-E03C64345287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742083" y="1060561"/>
            <a:ext cx="1829926" cy="18299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54127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</TotalTime>
  <Words>24</Words>
  <Application>Microsoft Macintosh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nveer Ahmed</dc:creator>
  <cp:lastModifiedBy>Tanveer Ahmed</cp:lastModifiedBy>
  <cp:revision>21</cp:revision>
  <dcterms:created xsi:type="dcterms:W3CDTF">2022-03-19T06:06:12Z</dcterms:created>
  <dcterms:modified xsi:type="dcterms:W3CDTF">2022-06-05T15:30:02Z</dcterms:modified>
</cp:coreProperties>
</file>